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82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662" autoAdjust="0"/>
    <p:restoredTop sz="93519" autoAdjust="0"/>
  </p:normalViewPr>
  <p:slideViewPr>
    <p:cSldViewPr snapToGrid="0">
      <p:cViewPr varScale="1">
        <p:scale>
          <a:sx n="66" d="100"/>
          <a:sy n="66" d="100"/>
        </p:scale>
        <p:origin x="72" y="10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533CD1D0-C11B-4350-9105-3F7BFD29B925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69CB7560-F9AA-4754-9263-F6789B53777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4886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72BB5-2F99-4A92-BFEC-C41F67F2BCE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842C688-6E9B-4928-B4FE-C80BD433F5E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2" indent="0" algn="ctr">
              <a:buNone/>
              <a:defRPr sz="2000"/>
            </a:lvl2pPr>
            <a:lvl3pPr marL="914363" indent="0" algn="ctr">
              <a:buNone/>
              <a:defRPr sz="1800"/>
            </a:lvl3pPr>
            <a:lvl4pPr marL="1371545" indent="0" algn="ctr">
              <a:buNone/>
              <a:defRPr sz="1600"/>
            </a:lvl4pPr>
            <a:lvl5pPr marL="1828727" indent="0" algn="ctr">
              <a:buNone/>
              <a:defRPr sz="1600"/>
            </a:lvl5pPr>
            <a:lvl6pPr marL="2285909" indent="0" algn="ctr">
              <a:buNone/>
              <a:defRPr sz="1600"/>
            </a:lvl6pPr>
            <a:lvl7pPr marL="2743090" indent="0" algn="ctr">
              <a:buNone/>
              <a:defRPr sz="1600"/>
            </a:lvl7pPr>
            <a:lvl8pPr marL="3200272" indent="0" algn="ctr">
              <a:buNone/>
              <a:defRPr sz="1600"/>
            </a:lvl8pPr>
            <a:lvl9pPr marL="3657454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D794B86-4636-4F47-BB32-E5C87A7B91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1C447-9170-4F0B-836C-0E6136CAB338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2771B4-E270-4D1E-8CCC-1F860C7847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061AAC-2C84-4D00-92AC-5CAB1A79B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8A9D7-8EA9-48DC-8CB1-C23EF78685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6580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C42ABF-A284-4F5F-B883-CC7CC8D7337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6891379-1357-4CDD-9595-BB4E155255E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EE9067F-C3A5-4457-982E-36A95BF93C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1C447-9170-4F0B-836C-0E6136CAB338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A50FC5-F8AA-430D-A776-672A50D502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74A223-61A5-4A16-9583-8F41A215EB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8A9D7-8EA9-48DC-8CB1-C23EF78685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9295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0B0D088-3B13-4BD0-9698-5FB9E4F568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C7776C-0AF0-4856-A034-69FD8E7CDC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D7608F-F54A-4B1C-A090-325549ECF4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1C447-9170-4F0B-836C-0E6136CAB338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761D47-020D-4F5D-9C62-CA49FD494E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390687-6479-439E-A211-CFF1D7BC7B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8A9D7-8EA9-48DC-8CB1-C23EF78685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9461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C8BC51-6F7E-4700-A1B4-7B881C32D3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ACC75E8-14A1-4C1D-B33E-B95D7961F2D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326EDD-807F-48A5-9BAD-5024F03D62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1C447-9170-4F0B-836C-0E6136CAB338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8B76C5-3E5B-494C-8098-D84B941059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56183D-6FD3-461C-B7B3-B84BC16586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8A9D7-8EA9-48DC-8CB1-C23EF78685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7954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4F0C1D-E7AA-4B81-908E-0570E451DD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0D728F4-3B51-41B5-ACA6-34E18EEECB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82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2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9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7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67FDF9-712D-4FAA-9B29-E19FBA2A8F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1C447-9170-4F0B-836C-0E6136CAB338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D71AE4-1F86-4F38-AEC8-16FFC89A04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5F5BFA-EFA4-4609-8739-856E138E38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8A9D7-8EA9-48DC-8CB1-C23EF78685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94323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13BF13-2FDA-44CF-AC9E-F21DEF46EB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A0F38E-17D8-4104-B8CF-88256702BD3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68116A-756D-4A47-AA75-49FF3D8AEC0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F7C7C32-D9F0-41A4-AEEF-5C450D57BA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1C447-9170-4F0B-836C-0E6136CAB338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8522DF9-531E-4802-97B4-A5221A7E0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E86121-2AF6-4DA6-A715-94386CBA7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8A9D7-8EA9-48DC-8CB1-C23EF78685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8269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3DC7C6-1223-4CCD-AAF5-3AFC25681B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B905493-194E-41A7-96D5-EDFE3ACA0F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90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2" indent="0">
              <a:buNone/>
              <a:defRPr sz="2000" b="1"/>
            </a:lvl2pPr>
            <a:lvl3pPr marL="914363" indent="0">
              <a:buNone/>
              <a:defRPr sz="1800" b="1"/>
            </a:lvl3pPr>
            <a:lvl4pPr marL="1371545" indent="0">
              <a:buNone/>
              <a:defRPr sz="1600" b="1"/>
            </a:lvl4pPr>
            <a:lvl5pPr marL="1828727" indent="0">
              <a:buNone/>
              <a:defRPr sz="1600" b="1"/>
            </a:lvl5pPr>
            <a:lvl6pPr marL="2285909" indent="0">
              <a:buNone/>
              <a:defRPr sz="1600" b="1"/>
            </a:lvl6pPr>
            <a:lvl7pPr marL="2743090" indent="0">
              <a:buNone/>
              <a:defRPr sz="1600" b="1"/>
            </a:lvl7pPr>
            <a:lvl8pPr marL="3200272" indent="0">
              <a:buNone/>
              <a:defRPr sz="1600" b="1"/>
            </a:lvl8pPr>
            <a:lvl9pPr marL="3657454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0E07F2C-AFC0-48F1-81EE-C67F6E5231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90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2E11412-F13D-4C83-8F95-208A0EE94BD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2" indent="0">
              <a:buNone/>
              <a:defRPr sz="2000" b="1"/>
            </a:lvl2pPr>
            <a:lvl3pPr marL="914363" indent="0">
              <a:buNone/>
              <a:defRPr sz="1800" b="1"/>
            </a:lvl3pPr>
            <a:lvl4pPr marL="1371545" indent="0">
              <a:buNone/>
              <a:defRPr sz="1600" b="1"/>
            </a:lvl4pPr>
            <a:lvl5pPr marL="1828727" indent="0">
              <a:buNone/>
              <a:defRPr sz="1600" b="1"/>
            </a:lvl5pPr>
            <a:lvl6pPr marL="2285909" indent="0">
              <a:buNone/>
              <a:defRPr sz="1600" b="1"/>
            </a:lvl6pPr>
            <a:lvl7pPr marL="2743090" indent="0">
              <a:buNone/>
              <a:defRPr sz="1600" b="1"/>
            </a:lvl7pPr>
            <a:lvl8pPr marL="3200272" indent="0">
              <a:buNone/>
              <a:defRPr sz="1600" b="1"/>
            </a:lvl8pPr>
            <a:lvl9pPr marL="3657454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5209567-70A3-4FFE-848B-E0F538288F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86B336D-2B47-4385-9EE2-DBC89247DE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1C447-9170-4F0B-836C-0E6136CAB338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3A91987-6DDF-41A5-BC06-1449749E05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19CB82A-DA96-4F80-B16F-4C7E6DA1D3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8A9D7-8EA9-48DC-8CB1-C23EF78685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15631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A4155A-7A91-411A-8481-A3D697AF9A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C0B6E4F-0E8C-4AA3-A3EB-55AE027503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1C447-9170-4F0B-836C-0E6136CAB338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2CBCBA-9B99-49CD-ACA7-09C639A9EA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150966A-2063-4473-B693-B3F329568E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8A9D7-8EA9-48DC-8CB1-C23EF78685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0912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A477F2E-2E9B-4AF8-B087-6E8E158B37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1C447-9170-4F0B-836C-0E6136CAB338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E214F22-CCD1-4464-9115-A8DD088477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603FD54-AAE8-4027-AEB3-E26B5ADB7C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8A9D7-8EA9-48DC-8CB1-C23EF78685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435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7CEE50-4869-423F-BEFE-0DBAB1C4E3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5B6F06-D231-4502-9DD2-E2C85D5780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49286AB-2C88-40F9-8AE9-89D7A4DB3C8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2" indent="0">
              <a:buNone/>
              <a:defRPr sz="1400"/>
            </a:lvl2pPr>
            <a:lvl3pPr marL="914363" indent="0">
              <a:buNone/>
              <a:defRPr sz="1200"/>
            </a:lvl3pPr>
            <a:lvl4pPr marL="1371545" indent="0">
              <a:buNone/>
              <a:defRPr sz="1000"/>
            </a:lvl4pPr>
            <a:lvl5pPr marL="1828727" indent="0">
              <a:buNone/>
              <a:defRPr sz="1000"/>
            </a:lvl5pPr>
            <a:lvl6pPr marL="2285909" indent="0">
              <a:buNone/>
              <a:defRPr sz="1000"/>
            </a:lvl6pPr>
            <a:lvl7pPr marL="2743090" indent="0">
              <a:buNone/>
              <a:defRPr sz="1000"/>
            </a:lvl7pPr>
            <a:lvl8pPr marL="3200272" indent="0">
              <a:buNone/>
              <a:defRPr sz="1000"/>
            </a:lvl8pPr>
            <a:lvl9pPr marL="3657454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E824CD-C47B-4A4D-94E2-AF75B552DB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1C447-9170-4F0B-836C-0E6136CAB338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3E7D0F-62DE-4ABC-97C9-94D31141D8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ADFFC4A-8D07-4BC4-8753-705F5A8190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8A9D7-8EA9-48DC-8CB1-C23EF78685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043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77274EF-C2B3-4DC6-9E4F-25D920CAD9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68C6963-F78E-4111-8587-5EFE21521B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82" indent="0">
              <a:buNone/>
              <a:defRPr sz="2800"/>
            </a:lvl2pPr>
            <a:lvl3pPr marL="914363" indent="0">
              <a:buNone/>
              <a:defRPr sz="2400"/>
            </a:lvl3pPr>
            <a:lvl4pPr marL="1371545" indent="0">
              <a:buNone/>
              <a:defRPr sz="2000"/>
            </a:lvl4pPr>
            <a:lvl5pPr marL="1828727" indent="0">
              <a:buNone/>
              <a:defRPr sz="2000"/>
            </a:lvl5pPr>
            <a:lvl6pPr marL="2285909" indent="0">
              <a:buNone/>
              <a:defRPr sz="2000"/>
            </a:lvl6pPr>
            <a:lvl7pPr marL="2743090" indent="0">
              <a:buNone/>
              <a:defRPr sz="2000"/>
            </a:lvl7pPr>
            <a:lvl8pPr marL="3200272" indent="0">
              <a:buNone/>
              <a:defRPr sz="2000"/>
            </a:lvl8pPr>
            <a:lvl9pPr marL="3657454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47F1A8-47E0-46E3-9106-3A6E6A8AD27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2" indent="0">
              <a:buNone/>
              <a:defRPr sz="1400"/>
            </a:lvl2pPr>
            <a:lvl3pPr marL="914363" indent="0">
              <a:buNone/>
              <a:defRPr sz="1200"/>
            </a:lvl3pPr>
            <a:lvl4pPr marL="1371545" indent="0">
              <a:buNone/>
              <a:defRPr sz="1000"/>
            </a:lvl4pPr>
            <a:lvl5pPr marL="1828727" indent="0">
              <a:buNone/>
              <a:defRPr sz="1000"/>
            </a:lvl5pPr>
            <a:lvl6pPr marL="2285909" indent="0">
              <a:buNone/>
              <a:defRPr sz="1000"/>
            </a:lvl6pPr>
            <a:lvl7pPr marL="2743090" indent="0">
              <a:buNone/>
              <a:defRPr sz="1000"/>
            </a:lvl7pPr>
            <a:lvl8pPr marL="3200272" indent="0">
              <a:buNone/>
              <a:defRPr sz="1000"/>
            </a:lvl8pPr>
            <a:lvl9pPr marL="3657454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869B62-B220-4203-91FA-8626971670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61C447-9170-4F0B-836C-0E6136CAB338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5BAAC57-D25F-4504-AF9A-4B2E97464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C2F1C0-51E0-40B5-828D-FCEF7D083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D8A9D7-8EA9-48DC-8CB1-C23EF78685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7925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B43647E-E9B7-46AE-807D-942378575D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CFA6C7-6F1D-47C1-A2D7-46D0FD59AC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DEED0A-E503-4CF1-93A9-CAB25A1374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61C447-9170-4F0B-836C-0E6136CAB338}" type="datetimeFigureOut">
              <a:rPr lang="en-US" smtClean="0"/>
              <a:t>8/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365479A-B412-471D-9ADF-642A73D225F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F411AC-2AB3-4645-9FBC-5ECC2F664E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D8A9D7-8EA9-48DC-8CB1-C23EF78685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7238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63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3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73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4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6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8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9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81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63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45" indent="-228591" algn="l" defTabSz="914363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2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3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5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7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9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90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72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54" algn="l" defTabSz="914363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emf"/><Relationship Id="rId13" Type="http://schemas.openxmlformats.org/officeDocument/2006/relationships/image" Target="../media/image9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2.bin"/><Relationship Id="rId12" Type="http://schemas.openxmlformats.org/officeDocument/2006/relationships/image" Target="../media/image8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jpeg"/><Relationship Id="rId11" Type="http://schemas.openxmlformats.org/officeDocument/2006/relationships/image" Target="../media/image7.jpeg"/><Relationship Id="rId5" Type="http://schemas.openxmlformats.org/officeDocument/2006/relationships/image" Target="../media/image3.jpeg"/><Relationship Id="rId10" Type="http://schemas.openxmlformats.org/officeDocument/2006/relationships/image" Target="../media/image6.jpeg"/><Relationship Id="rId4" Type="http://schemas.openxmlformats.org/officeDocument/2006/relationships/image" Target="../media/image1.emf"/><Relationship Id="rId9" Type="http://schemas.openxmlformats.org/officeDocument/2006/relationships/image" Target="../media/image5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EE3065F3-B1B1-4F4F-8DCD-6FD5C57AC025}"/>
              </a:ext>
            </a:extLst>
          </p:cNvPr>
          <p:cNvSpPr txBox="1"/>
          <p:nvPr/>
        </p:nvSpPr>
        <p:spPr>
          <a:xfrm>
            <a:off x="0" y="28135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E320E878-DD79-4876-88D0-EF37AB0FF2F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89364828"/>
              </p:ext>
            </p:extLst>
          </p:nvPr>
        </p:nvGraphicFramePr>
        <p:xfrm>
          <a:off x="3479956" y="1080882"/>
          <a:ext cx="3448050" cy="2616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2" name="Prism 6" r:id="rId3" imgW="3448660" imgH="2616159" progId="Prism6.Document">
                  <p:embed/>
                </p:oleObj>
              </mc:Choice>
              <mc:Fallback>
                <p:oleObj name="Prism 6" r:id="rId3" imgW="3448660" imgH="2616159" progId="Prism6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E320E878-DD79-4876-88D0-EF37AB0FF2F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479956" y="1080882"/>
                        <a:ext cx="3448050" cy="2616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988A9C62-73DB-47E0-83BD-9B021C140B9A}"/>
              </a:ext>
            </a:extLst>
          </p:cNvPr>
          <p:cNvCxnSpPr/>
          <p:nvPr/>
        </p:nvCxnSpPr>
        <p:spPr>
          <a:xfrm>
            <a:off x="4680106" y="1379332"/>
            <a:ext cx="142875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>
            <a:extLst>
              <a:ext uri="{FF2B5EF4-FFF2-40B4-BE49-F238E27FC236}">
                <a16:creationId xmlns:a16="http://schemas.microsoft.com/office/drawing/2014/main" id="{9A6EEEAB-27B3-4F76-9E67-784390D2A259}"/>
              </a:ext>
            </a:extLst>
          </p:cNvPr>
          <p:cNvSpPr txBox="1"/>
          <p:nvPr/>
        </p:nvSpPr>
        <p:spPr>
          <a:xfrm>
            <a:off x="5203981" y="1130194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F02E8B7-6480-479C-8FDD-61533F2849B9}"/>
              </a:ext>
            </a:extLst>
          </p:cNvPr>
          <p:cNvSpPr txBox="1"/>
          <p:nvPr/>
        </p:nvSpPr>
        <p:spPr>
          <a:xfrm>
            <a:off x="1451428" y="73867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B3A39C8C-6B7C-4833-91DC-B2BDB2371070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3894" y="1156012"/>
            <a:ext cx="1387576" cy="104411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34E2162-542D-4486-A02E-0AE72F36FC90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8510" y="2270812"/>
            <a:ext cx="1387576" cy="104411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31FBF459-B677-4589-B3BD-735F7CFC9D9E}"/>
              </a:ext>
            </a:extLst>
          </p:cNvPr>
          <p:cNvSpPr txBox="1"/>
          <p:nvPr/>
        </p:nvSpPr>
        <p:spPr>
          <a:xfrm rot="16200000">
            <a:off x="1249665" y="1539571"/>
            <a:ext cx="10441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S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5A150C3-EECF-4BA2-8F4A-1A1AF71C91AC}"/>
              </a:ext>
            </a:extLst>
          </p:cNvPr>
          <p:cNvSpPr txBox="1"/>
          <p:nvPr/>
        </p:nvSpPr>
        <p:spPr>
          <a:xfrm rot="16200000">
            <a:off x="1249667" y="2654370"/>
            <a:ext cx="10441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LP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B612421-8614-4E7E-AB4B-631BD3050081}"/>
              </a:ext>
            </a:extLst>
          </p:cNvPr>
          <p:cNvSpPr txBox="1"/>
          <p:nvPr/>
        </p:nvSpPr>
        <p:spPr>
          <a:xfrm>
            <a:off x="3421160" y="738679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441E1F1-BA70-481E-A753-FE0FBA307AC6}"/>
              </a:ext>
            </a:extLst>
          </p:cNvPr>
          <p:cNvSpPr txBox="1"/>
          <p:nvPr/>
        </p:nvSpPr>
        <p:spPr>
          <a:xfrm>
            <a:off x="6756513" y="734731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14FB0D59-6111-4110-91EA-1093D9934451}"/>
              </a:ext>
            </a:extLst>
          </p:cNvPr>
          <p:cNvCxnSpPr/>
          <p:nvPr/>
        </p:nvCxnSpPr>
        <p:spPr>
          <a:xfrm>
            <a:off x="8324283" y="1579551"/>
            <a:ext cx="142875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667B04CE-E853-4590-B14D-D93E0CBC4D54}"/>
              </a:ext>
            </a:extLst>
          </p:cNvPr>
          <p:cNvSpPr txBox="1"/>
          <p:nvPr/>
        </p:nvSpPr>
        <p:spPr>
          <a:xfrm>
            <a:off x="8820726" y="1359979"/>
            <a:ext cx="46679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****</a:t>
            </a:r>
          </a:p>
        </p:txBody>
      </p:sp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8C361152-87BD-42A8-9CEA-0CC0D82D615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65575193"/>
              </p:ext>
            </p:extLst>
          </p:nvPr>
        </p:nvGraphicFramePr>
        <p:xfrm>
          <a:off x="6928007" y="1080882"/>
          <a:ext cx="3559175" cy="2616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3" name="Prism 6" r:id="rId7" imgW="3558501" imgH="2616159" progId="Prism6.Document">
                  <p:embed/>
                </p:oleObj>
              </mc:Choice>
              <mc:Fallback>
                <p:oleObj name="Prism 6" r:id="rId7" imgW="3558501" imgH="2616159" progId="Prism6.Document">
                  <p:embed/>
                  <p:pic>
                    <p:nvPicPr>
                      <p:cNvPr id="16" name="Object 15">
                        <a:extLst>
                          <a:ext uri="{FF2B5EF4-FFF2-40B4-BE49-F238E27FC236}">
                            <a16:creationId xmlns:a16="http://schemas.microsoft.com/office/drawing/2014/main" id="{8C361152-87BD-42A8-9CEA-0CC0D82D615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6928007" y="1080882"/>
                        <a:ext cx="3559175" cy="2616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6F84CF2A-66E5-4502-BDEF-076AB561357E}"/>
              </a:ext>
            </a:extLst>
          </p:cNvPr>
          <p:cNvSpPr txBox="1"/>
          <p:nvPr/>
        </p:nvSpPr>
        <p:spPr>
          <a:xfrm>
            <a:off x="3030498" y="4023733"/>
            <a:ext cx="11686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400" dirty="0"/>
              <a:t>LPA: 48 hours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6B29785-47E2-4AF6-8861-59B3F6876E9B}"/>
              </a:ext>
            </a:extLst>
          </p:cNvPr>
          <p:cNvSpPr txBox="1"/>
          <p:nvPr/>
        </p:nvSpPr>
        <p:spPr>
          <a:xfrm>
            <a:off x="3338323" y="3964058"/>
            <a:ext cx="338554" cy="81369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 µM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53F82AF-D29E-425B-9B4F-E3BB63EE0231}"/>
              </a:ext>
            </a:extLst>
          </p:cNvPr>
          <p:cNvSpPr txBox="1"/>
          <p:nvPr/>
        </p:nvSpPr>
        <p:spPr>
          <a:xfrm>
            <a:off x="3069455" y="4012890"/>
            <a:ext cx="338554" cy="76486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 µM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94703149-5D2A-46F3-8450-E06307FDE505}"/>
              </a:ext>
            </a:extLst>
          </p:cNvPr>
          <p:cNvSpPr txBox="1"/>
          <p:nvPr/>
        </p:nvSpPr>
        <p:spPr>
          <a:xfrm>
            <a:off x="3591539" y="4208161"/>
            <a:ext cx="338554" cy="56959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0 µM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C52D5C5-CE83-4CF0-8A48-41E483E673A5}"/>
              </a:ext>
            </a:extLst>
          </p:cNvPr>
          <p:cNvSpPr txBox="1"/>
          <p:nvPr/>
        </p:nvSpPr>
        <p:spPr>
          <a:xfrm>
            <a:off x="3827901" y="4182331"/>
            <a:ext cx="338554" cy="59542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0 µM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59E3F2D1-EB46-443F-B29F-08479CA2D22A}"/>
              </a:ext>
            </a:extLst>
          </p:cNvPr>
          <p:cNvCxnSpPr/>
          <p:nvPr/>
        </p:nvCxnSpPr>
        <p:spPr>
          <a:xfrm>
            <a:off x="3004129" y="4335342"/>
            <a:ext cx="1188720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E3DA4BDE-E8B4-4C2A-941B-F2640AB9709D}"/>
              </a:ext>
            </a:extLst>
          </p:cNvPr>
          <p:cNvSpPr txBox="1"/>
          <p:nvPr/>
        </p:nvSpPr>
        <p:spPr>
          <a:xfrm>
            <a:off x="4421394" y="4962002"/>
            <a:ext cx="5116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CD71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FBEC23D9-8AF8-497D-9CD2-3B74263254D9}"/>
              </a:ext>
            </a:extLst>
          </p:cNvPr>
          <p:cNvCxnSpPr>
            <a:cxnSpLocks/>
          </p:cNvCxnSpPr>
          <p:nvPr/>
        </p:nvCxnSpPr>
        <p:spPr>
          <a:xfrm>
            <a:off x="4292162" y="5067839"/>
            <a:ext cx="173736" cy="0"/>
          </a:xfrm>
          <a:prstGeom prst="line">
            <a:avLst/>
          </a:prstGeom>
          <a:ln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581FD529-1D27-4821-8880-30D5B80B8349}"/>
              </a:ext>
            </a:extLst>
          </p:cNvPr>
          <p:cNvSpPr txBox="1"/>
          <p:nvPr/>
        </p:nvSpPr>
        <p:spPr>
          <a:xfrm>
            <a:off x="2327319" y="4991245"/>
            <a:ext cx="5950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latin typeface="Arial"/>
                <a:cs typeface="Arial"/>
              </a:rPr>
              <a:t>76 kDa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AA807B3D-E1E6-4782-94CD-DF3B3861804F}"/>
              </a:ext>
            </a:extLst>
          </p:cNvPr>
          <p:cNvCxnSpPr>
            <a:cxnSpLocks/>
          </p:cNvCxnSpPr>
          <p:nvPr/>
        </p:nvCxnSpPr>
        <p:spPr>
          <a:xfrm>
            <a:off x="2845184" y="5114355"/>
            <a:ext cx="173736" cy="0"/>
          </a:xfrm>
          <a:prstGeom prst="line">
            <a:avLst/>
          </a:prstGeom>
          <a:ln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7" name="Picture 26">
            <a:extLst>
              <a:ext uri="{FF2B5EF4-FFF2-40B4-BE49-F238E27FC236}">
                <a16:creationId xmlns:a16="http://schemas.microsoft.com/office/drawing/2014/main" id="{DB3EB7B1-800F-4EE5-879C-D5EA08EE6187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11" t="88349" r="58901" b="7477"/>
          <a:stretch/>
        </p:blipFill>
        <p:spPr>
          <a:xfrm>
            <a:off x="3069456" y="5290799"/>
            <a:ext cx="1123394" cy="366455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63C3C149-C463-4F5C-8BA2-CDF794244F38}"/>
              </a:ext>
            </a:extLst>
          </p:cNvPr>
          <p:cNvSpPr txBox="1"/>
          <p:nvPr/>
        </p:nvSpPr>
        <p:spPr>
          <a:xfrm>
            <a:off x="4421394" y="5375640"/>
            <a:ext cx="50526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FTH1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D804B94A-04C3-435F-A1C1-1923E4A0A34D}"/>
              </a:ext>
            </a:extLst>
          </p:cNvPr>
          <p:cNvCxnSpPr>
            <a:cxnSpLocks/>
          </p:cNvCxnSpPr>
          <p:nvPr/>
        </p:nvCxnSpPr>
        <p:spPr>
          <a:xfrm>
            <a:off x="4292162" y="5481477"/>
            <a:ext cx="173736" cy="0"/>
          </a:xfrm>
          <a:prstGeom prst="line">
            <a:avLst/>
          </a:prstGeom>
          <a:ln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27884BDA-8576-4FE6-9BB5-39B7091A53FB}"/>
              </a:ext>
            </a:extLst>
          </p:cNvPr>
          <p:cNvSpPr txBox="1"/>
          <p:nvPr/>
        </p:nvSpPr>
        <p:spPr>
          <a:xfrm>
            <a:off x="2327319" y="5379245"/>
            <a:ext cx="5950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latin typeface="Arial"/>
                <a:cs typeface="Arial"/>
              </a:rPr>
              <a:t>17 kDa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75FA7925-1AC6-4F52-969F-FA872657E961}"/>
              </a:ext>
            </a:extLst>
          </p:cNvPr>
          <p:cNvCxnSpPr>
            <a:cxnSpLocks/>
          </p:cNvCxnSpPr>
          <p:nvPr/>
        </p:nvCxnSpPr>
        <p:spPr>
          <a:xfrm>
            <a:off x="2845184" y="5502355"/>
            <a:ext cx="173736" cy="0"/>
          </a:xfrm>
          <a:prstGeom prst="line">
            <a:avLst/>
          </a:prstGeom>
          <a:ln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2" name="Picture 31">
            <a:extLst>
              <a:ext uri="{FF2B5EF4-FFF2-40B4-BE49-F238E27FC236}">
                <a16:creationId xmlns:a16="http://schemas.microsoft.com/office/drawing/2014/main" id="{87D62A25-60BA-4611-98A6-0F7C9DECB329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964" t="66532" r="18099" b="21098"/>
          <a:stretch/>
        </p:blipFill>
        <p:spPr>
          <a:xfrm rot="5400000">
            <a:off x="3450083" y="5353664"/>
            <a:ext cx="362140" cy="1123395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6C8863BE-DC74-4F8A-8F97-AF2E7F4F5A7E}"/>
              </a:ext>
            </a:extLst>
          </p:cNvPr>
          <p:cNvSpPr txBox="1"/>
          <p:nvPr/>
        </p:nvSpPr>
        <p:spPr>
          <a:xfrm>
            <a:off x="4421394" y="5812414"/>
            <a:ext cx="782587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Pan-Actin</a:t>
            </a:r>
          </a:p>
        </p:txBody>
      </p: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C0F7298D-666A-4E17-B827-2383A96B22C0}"/>
              </a:ext>
            </a:extLst>
          </p:cNvPr>
          <p:cNvCxnSpPr>
            <a:cxnSpLocks/>
          </p:cNvCxnSpPr>
          <p:nvPr/>
        </p:nvCxnSpPr>
        <p:spPr>
          <a:xfrm>
            <a:off x="4292162" y="5918251"/>
            <a:ext cx="173736" cy="0"/>
          </a:xfrm>
          <a:prstGeom prst="line">
            <a:avLst/>
          </a:prstGeom>
          <a:ln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>
            <a:extLst>
              <a:ext uri="{FF2B5EF4-FFF2-40B4-BE49-F238E27FC236}">
                <a16:creationId xmlns:a16="http://schemas.microsoft.com/office/drawing/2014/main" id="{5AC988E4-0F57-439F-AB1C-4D9F519EFEE9}"/>
              </a:ext>
            </a:extLst>
          </p:cNvPr>
          <p:cNvSpPr txBox="1"/>
          <p:nvPr/>
        </p:nvSpPr>
        <p:spPr>
          <a:xfrm>
            <a:off x="2327319" y="5666871"/>
            <a:ext cx="5950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latin typeface="Arial"/>
                <a:cs typeface="Arial"/>
              </a:rPr>
              <a:t>52 kDa</a:t>
            </a:r>
          </a:p>
        </p:txBody>
      </p: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4D50468D-5029-4CE6-B8BB-DF5FF01C317C}"/>
              </a:ext>
            </a:extLst>
          </p:cNvPr>
          <p:cNvCxnSpPr>
            <a:cxnSpLocks/>
          </p:cNvCxnSpPr>
          <p:nvPr/>
        </p:nvCxnSpPr>
        <p:spPr>
          <a:xfrm>
            <a:off x="2845184" y="5789981"/>
            <a:ext cx="173736" cy="0"/>
          </a:xfrm>
          <a:prstGeom prst="line">
            <a:avLst/>
          </a:prstGeom>
          <a:ln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7" name="Picture 36">
            <a:extLst>
              <a:ext uri="{FF2B5EF4-FFF2-40B4-BE49-F238E27FC236}">
                <a16:creationId xmlns:a16="http://schemas.microsoft.com/office/drawing/2014/main" id="{D3A7F89A-87D9-49DF-B79D-9787C8C0EE63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891" t="49942" r="56527" b="45781"/>
          <a:stretch/>
        </p:blipFill>
        <p:spPr>
          <a:xfrm>
            <a:off x="3069455" y="4836740"/>
            <a:ext cx="1123394" cy="380692"/>
          </a:xfrm>
          <a:prstGeom prst="rect">
            <a:avLst/>
          </a:prstGeom>
        </p:spPr>
      </p:pic>
      <p:sp>
        <p:nvSpPr>
          <p:cNvPr id="38" name="TextBox 37">
            <a:extLst>
              <a:ext uri="{FF2B5EF4-FFF2-40B4-BE49-F238E27FC236}">
                <a16:creationId xmlns:a16="http://schemas.microsoft.com/office/drawing/2014/main" id="{68BB994A-BCDB-40C9-A910-E2F934C23247}"/>
              </a:ext>
            </a:extLst>
          </p:cNvPr>
          <p:cNvSpPr txBox="1"/>
          <p:nvPr/>
        </p:nvSpPr>
        <p:spPr>
          <a:xfrm>
            <a:off x="2327319" y="5564539"/>
            <a:ext cx="59503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000" b="1" dirty="0">
                <a:latin typeface="Arial"/>
                <a:cs typeface="Arial"/>
              </a:rPr>
              <a:t>38 kDa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FFB71C4D-7C06-4DCA-B9C4-37A990CD22F0}"/>
              </a:ext>
            </a:extLst>
          </p:cNvPr>
          <p:cNvCxnSpPr>
            <a:cxnSpLocks/>
          </p:cNvCxnSpPr>
          <p:nvPr/>
        </p:nvCxnSpPr>
        <p:spPr>
          <a:xfrm>
            <a:off x="2845184" y="5687649"/>
            <a:ext cx="173736" cy="0"/>
          </a:xfrm>
          <a:prstGeom prst="line">
            <a:avLst/>
          </a:prstGeom>
          <a:ln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0" name="Picture 39">
            <a:extLst>
              <a:ext uri="{FF2B5EF4-FFF2-40B4-BE49-F238E27FC236}">
                <a16:creationId xmlns:a16="http://schemas.microsoft.com/office/drawing/2014/main" id="{63F80B57-9617-4E5E-841C-AFB803119908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790364" y="4533004"/>
            <a:ext cx="1932298" cy="1685271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7C3E0B1C-E9B1-4DCF-AD20-CD85CABA536A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722662" y="4533004"/>
            <a:ext cx="1932298" cy="1685271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F80C8BFF-A6A1-4D25-AB64-3EFE860E07A6}"/>
              </a:ext>
            </a:extLst>
          </p:cNvPr>
          <p:cNvSpPr txBox="1"/>
          <p:nvPr/>
        </p:nvSpPr>
        <p:spPr>
          <a:xfrm>
            <a:off x="1481291" y="3839067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21927774-F90F-48C3-8FFD-37EFC172E644}"/>
              </a:ext>
            </a:extLst>
          </p:cNvPr>
          <p:cNvCxnSpPr/>
          <p:nvPr/>
        </p:nvCxnSpPr>
        <p:spPr>
          <a:xfrm>
            <a:off x="6284228" y="5054155"/>
            <a:ext cx="40233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Connector 43">
            <a:extLst>
              <a:ext uri="{FF2B5EF4-FFF2-40B4-BE49-F238E27FC236}">
                <a16:creationId xmlns:a16="http://schemas.microsoft.com/office/drawing/2014/main" id="{E9E2E2CB-4E89-426A-9365-DB9E088C11C8}"/>
              </a:ext>
            </a:extLst>
          </p:cNvPr>
          <p:cNvCxnSpPr/>
          <p:nvPr/>
        </p:nvCxnSpPr>
        <p:spPr>
          <a:xfrm>
            <a:off x="7030988" y="4895659"/>
            <a:ext cx="40233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E2069AB2-2A4B-4128-A0D8-70F51BAA60D1}"/>
              </a:ext>
            </a:extLst>
          </p:cNvPr>
          <p:cNvSpPr txBox="1"/>
          <p:nvPr/>
        </p:nvSpPr>
        <p:spPr>
          <a:xfrm>
            <a:off x="6347175" y="4877371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70511D8-D7EA-4203-91B9-A0B65AEDA889}"/>
              </a:ext>
            </a:extLst>
          </p:cNvPr>
          <p:cNvSpPr txBox="1"/>
          <p:nvPr/>
        </p:nvSpPr>
        <p:spPr>
          <a:xfrm>
            <a:off x="7093935" y="4728019"/>
            <a:ext cx="2936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E70223BD-957D-4D57-BA1D-0265B2E04AFE}"/>
              </a:ext>
            </a:extLst>
          </p:cNvPr>
          <p:cNvCxnSpPr>
            <a:cxnSpLocks/>
          </p:cNvCxnSpPr>
          <p:nvPr/>
        </p:nvCxnSpPr>
        <p:spPr>
          <a:xfrm>
            <a:off x="8188839" y="5270496"/>
            <a:ext cx="40233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885CEE76-8A3D-4C04-9058-94AB17F63518}"/>
              </a:ext>
            </a:extLst>
          </p:cNvPr>
          <p:cNvCxnSpPr>
            <a:cxnSpLocks/>
          </p:cNvCxnSpPr>
          <p:nvPr/>
        </p:nvCxnSpPr>
        <p:spPr>
          <a:xfrm>
            <a:off x="8990463" y="4873651"/>
            <a:ext cx="402336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32875EC2-9276-49A2-9570-934B8F7B6649}"/>
              </a:ext>
            </a:extLst>
          </p:cNvPr>
          <p:cNvSpPr txBox="1"/>
          <p:nvPr/>
        </p:nvSpPr>
        <p:spPr>
          <a:xfrm>
            <a:off x="8270074" y="5130288"/>
            <a:ext cx="2936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0D863CC2-BE55-4117-867D-3FFF993EF799}"/>
              </a:ext>
            </a:extLst>
          </p:cNvPr>
          <p:cNvSpPr txBox="1"/>
          <p:nvPr/>
        </p:nvSpPr>
        <p:spPr>
          <a:xfrm>
            <a:off x="9080842" y="4724299"/>
            <a:ext cx="2936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0835134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74</TotalTime>
  <Words>38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6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IO, Nanjundanlab</dc:creator>
  <cp:lastModifiedBy>Meera Nanjundan</cp:lastModifiedBy>
  <cp:revision>191</cp:revision>
  <cp:lastPrinted>2022-04-01T20:00:47Z</cp:lastPrinted>
  <dcterms:created xsi:type="dcterms:W3CDTF">2021-07-12T18:47:49Z</dcterms:created>
  <dcterms:modified xsi:type="dcterms:W3CDTF">2022-08-01T17:43:45Z</dcterms:modified>
</cp:coreProperties>
</file>